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7" d="100"/>
          <a:sy n="57" d="100"/>
        </p:scale>
        <p:origin x="190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__________Microsoft_Excel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__________Microsoft_Excel2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__________Microsoft_Excel3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__________Microsoft_Excel4.xlsx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__________Microsoft_Excel5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__________Microsoft_Excel6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129452809346413"/>
          <c:y val="2.8326176428484819E-2"/>
          <c:w val="0.81468455770524706"/>
          <c:h val="0.8140643014343141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R$50</c:f>
              <c:strCache>
                <c:ptCount val="1"/>
                <c:pt idx="0">
                  <c:v>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68:$O$68</c:f>
                <c:numCache>
                  <c:formatCode>General</c:formatCode>
                  <c:ptCount val="5"/>
                  <c:pt idx="0">
                    <c:v>1.3685710341003562E-2</c:v>
                  </c:pt>
                  <c:pt idx="1">
                    <c:v>0.22972442358112763</c:v>
                  </c:pt>
                  <c:pt idx="2">
                    <c:v>0.75271406875518343</c:v>
                  </c:pt>
                  <c:pt idx="3">
                    <c:v>7.5760182244838187E-2</c:v>
                  </c:pt>
                  <c:pt idx="4">
                    <c:v>0.54742841364013251</c:v>
                  </c:pt>
                </c:numCache>
              </c:numRef>
            </c:plus>
            <c:minus>
              <c:numRef>
                <c:f>Sheet1!$K$68:$O$68</c:f>
                <c:numCache>
                  <c:formatCode>General</c:formatCode>
                  <c:ptCount val="5"/>
                  <c:pt idx="0">
                    <c:v>1.3685710341003562E-2</c:v>
                  </c:pt>
                  <c:pt idx="1">
                    <c:v>0.22972442358112763</c:v>
                  </c:pt>
                  <c:pt idx="2">
                    <c:v>0.75271406875518343</c:v>
                  </c:pt>
                  <c:pt idx="3">
                    <c:v>7.5760182244838187E-2</c:v>
                  </c:pt>
                  <c:pt idx="4">
                    <c:v>0.547428413640132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49:$W$4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50:$W$50</c:f>
              <c:numCache>
                <c:formatCode>General</c:formatCode>
                <c:ptCount val="5"/>
                <c:pt idx="0">
                  <c:v>4.3112829853678996</c:v>
                </c:pt>
                <c:pt idx="1">
                  <c:v>13.123053877376835</c:v>
                </c:pt>
                <c:pt idx="2">
                  <c:v>14.833854949091746</c:v>
                </c:pt>
                <c:pt idx="3">
                  <c:v>14.507247471764353</c:v>
                </c:pt>
                <c:pt idx="4">
                  <c:v>14.32234270946789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BD59-40AD-A2B9-4D2CF0B40078}"/>
            </c:ext>
          </c:extLst>
        </c:ser>
        <c:ser>
          <c:idx val="1"/>
          <c:order val="1"/>
          <c:tx>
            <c:strRef>
              <c:f>Sheet1!$R$51</c:f>
              <c:strCache>
                <c:ptCount val="1"/>
                <c:pt idx="0">
                  <c:v>2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diamond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dPt>
            <c:idx val="2"/>
            <c:marker>
              <c:symbol val="diamond"/>
              <c:size val="5"/>
              <c:spPr>
                <a:noFill/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</c:dPt>
          <c:errBars>
            <c:errDir val="y"/>
            <c:errBarType val="both"/>
            <c:errValType val="cust"/>
            <c:noEndCap val="0"/>
            <c:plus>
              <c:numRef>
                <c:f>Sheet1!$K$69:$O$69</c:f>
                <c:numCache>
                  <c:formatCode>General</c:formatCode>
                  <c:ptCount val="5"/>
                  <c:pt idx="0">
                    <c:v>0.27371420682006598</c:v>
                  </c:pt>
                  <c:pt idx="1">
                    <c:v>1.8084688664897295</c:v>
                  </c:pt>
                  <c:pt idx="2">
                    <c:v>8.7979566477879689E-2</c:v>
                  </c:pt>
                  <c:pt idx="3">
                    <c:v>0.46922435454868494</c:v>
                  </c:pt>
                  <c:pt idx="4">
                    <c:v>0.70383653182302741</c:v>
                  </c:pt>
                </c:numCache>
              </c:numRef>
            </c:plus>
            <c:minus>
              <c:numRef>
                <c:f>Sheet1!$K$69:$O$69</c:f>
                <c:numCache>
                  <c:formatCode>General</c:formatCode>
                  <c:ptCount val="5"/>
                  <c:pt idx="0">
                    <c:v>0.27371420682006598</c:v>
                  </c:pt>
                  <c:pt idx="1">
                    <c:v>1.8084688664897295</c:v>
                  </c:pt>
                  <c:pt idx="2">
                    <c:v>8.7979566477879689E-2</c:v>
                  </c:pt>
                  <c:pt idx="3">
                    <c:v>0.46922435454868494</c:v>
                  </c:pt>
                  <c:pt idx="4">
                    <c:v>0.703836531823027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49:$W$4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51:$W$51</c:f>
              <c:numCache>
                <c:formatCode>General</c:formatCode>
                <c:ptCount val="5"/>
                <c:pt idx="0">
                  <c:v>5.3033948445235</c:v>
                </c:pt>
                <c:pt idx="1">
                  <c:v>46.029189238584316</c:v>
                </c:pt>
                <c:pt idx="2">
                  <c:v>49.1120873314524</c:v>
                </c:pt>
                <c:pt idx="3">
                  <c:v>68.23849769684702</c:v>
                </c:pt>
                <c:pt idx="4">
                  <c:v>80.210649035070176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BD59-40AD-A2B9-4D2CF0B40078}"/>
            </c:ext>
          </c:extLst>
        </c:ser>
        <c:ser>
          <c:idx val="2"/>
          <c:order val="2"/>
          <c:tx>
            <c:strRef>
              <c:f>Sheet1!$R$52</c:f>
              <c:strCache>
                <c:ptCount val="1"/>
                <c:pt idx="0">
                  <c:v>5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70:$O$70</c:f>
                <c:numCache>
                  <c:formatCode>General</c:formatCode>
                  <c:ptCount val="5"/>
                  <c:pt idx="0">
                    <c:v>0.37146928068437807</c:v>
                  </c:pt>
                  <c:pt idx="1">
                    <c:v>0.29326522159292556</c:v>
                  </c:pt>
                  <c:pt idx="2">
                    <c:v>0.37146928068437807</c:v>
                  </c:pt>
                  <c:pt idx="3">
                    <c:v>0.64518348750443433</c:v>
                  </c:pt>
                  <c:pt idx="4">
                    <c:v>0.91889769432449542</c:v>
                  </c:pt>
                </c:numCache>
              </c:numRef>
            </c:plus>
            <c:minus>
              <c:numRef>
                <c:f>Sheet1!$K$70:$O$70</c:f>
                <c:numCache>
                  <c:formatCode>General</c:formatCode>
                  <c:ptCount val="5"/>
                  <c:pt idx="0">
                    <c:v>0.37146928068437807</c:v>
                  </c:pt>
                  <c:pt idx="1">
                    <c:v>0.29326522159292556</c:v>
                  </c:pt>
                  <c:pt idx="2">
                    <c:v>0.37146928068437807</c:v>
                  </c:pt>
                  <c:pt idx="3">
                    <c:v>0.64518348750443433</c:v>
                  </c:pt>
                  <c:pt idx="4">
                    <c:v>0.918897694324495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49:$W$4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52:$W$52</c:f>
              <c:numCache>
                <c:formatCode>General</c:formatCode>
                <c:ptCount val="5"/>
                <c:pt idx="0">
                  <c:v>9.1604736243898</c:v>
                </c:pt>
                <c:pt idx="1">
                  <c:v>55.920729980499637</c:v>
                </c:pt>
                <c:pt idx="2">
                  <c:v>63.427517713357815</c:v>
                </c:pt>
                <c:pt idx="3">
                  <c:v>78.371969903449298</c:v>
                </c:pt>
                <c:pt idx="4">
                  <c:v>89.22432417654998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BD59-40AD-A2B9-4D2CF0B40078}"/>
            </c:ext>
          </c:extLst>
        </c:ser>
        <c:ser>
          <c:idx val="3"/>
          <c:order val="3"/>
          <c:tx>
            <c:strRef>
              <c:f>Sheet1!$R$53</c:f>
              <c:strCache>
                <c:ptCount val="1"/>
                <c:pt idx="0">
                  <c:v>7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77:$DA$77</c:f>
                <c:numCache>
                  <c:formatCode>General</c:formatCode>
                  <c:ptCount val="5"/>
                  <c:pt idx="0">
                    <c:v>4.3983355166258873</c:v>
                  </c:pt>
                  <c:pt idx="1">
                    <c:v>8.0457357011468403E-2</c:v>
                  </c:pt>
                  <c:pt idx="2">
                    <c:v>2.2528059963206024</c:v>
                  </c:pt>
                  <c:pt idx="3">
                    <c:v>0.40228678505726162</c:v>
                  </c:pt>
                  <c:pt idx="4">
                    <c:v>3.1646560424503329</c:v>
                  </c:pt>
                </c:numCache>
              </c:numRef>
            </c:plus>
            <c:minus>
              <c:numRef>
                <c:f>DPPH!$CW$77:$DA$77</c:f>
                <c:numCache>
                  <c:formatCode>General</c:formatCode>
                  <c:ptCount val="5"/>
                  <c:pt idx="0">
                    <c:v>4.3983355166258873</c:v>
                  </c:pt>
                  <c:pt idx="1">
                    <c:v>8.0457357011468403E-2</c:v>
                  </c:pt>
                  <c:pt idx="2">
                    <c:v>2.2528059963206024</c:v>
                  </c:pt>
                  <c:pt idx="3">
                    <c:v>0.40228678505726162</c:v>
                  </c:pt>
                  <c:pt idx="4">
                    <c:v>3.16465604245033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49:$W$4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53:$W$53</c:f>
              <c:numCache>
                <c:formatCode>General</c:formatCode>
                <c:ptCount val="5"/>
                <c:pt idx="0">
                  <c:v>11.089013014322999</c:v>
                </c:pt>
                <c:pt idx="1">
                  <c:v>57.317020148121493</c:v>
                </c:pt>
                <c:pt idx="2">
                  <c:v>63.800783401731984</c:v>
                </c:pt>
                <c:pt idx="3">
                  <c:v>72.759159922711888</c:v>
                </c:pt>
                <c:pt idx="4">
                  <c:v>88.367195558801896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BD59-40AD-A2B9-4D2CF0B40078}"/>
            </c:ext>
          </c:extLst>
        </c:ser>
        <c:ser>
          <c:idx val="4"/>
          <c:order val="4"/>
          <c:tx>
            <c:strRef>
              <c:f>Sheet1!$R$54</c:f>
              <c:strCache>
                <c:ptCount val="1"/>
                <c:pt idx="0">
                  <c:v>1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78:$DA$78</c:f>
                <c:numCache>
                  <c:formatCode>General</c:formatCode>
                  <c:ptCount val="5"/>
                  <c:pt idx="0">
                    <c:v>2.4941780673549072</c:v>
                  </c:pt>
                  <c:pt idx="1">
                    <c:v>0.93866916513357024</c:v>
                  </c:pt>
                  <c:pt idx="2">
                    <c:v>1.6091471402289861</c:v>
                  </c:pt>
                  <c:pt idx="3">
                    <c:v>0.34864854704958254</c:v>
                  </c:pt>
                  <c:pt idx="4">
                    <c:v>1.1264029981602763</c:v>
                  </c:pt>
                </c:numCache>
              </c:numRef>
            </c:plus>
            <c:minus>
              <c:numRef>
                <c:f>DPPH!$CW$78:$DA$78</c:f>
                <c:numCache>
                  <c:formatCode>General</c:formatCode>
                  <c:ptCount val="5"/>
                  <c:pt idx="0">
                    <c:v>2.4941780673549072</c:v>
                  </c:pt>
                  <c:pt idx="1">
                    <c:v>0.93866916513357024</c:v>
                  </c:pt>
                  <c:pt idx="2">
                    <c:v>1.6091471402289861</c:v>
                  </c:pt>
                  <c:pt idx="3">
                    <c:v>0.34864854704958254</c:v>
                  </c:pt>
                  <c:pt idx="4">
                    <c:v>1.12640299816027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49:$W$4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54:$W$54</c:f>
              <c:numCache>
                <c:formatCode>General</c:formatCode>
                <c:ptCount val="5"/>
                <c:pt idx="0">
                  <c:v>12.275296993337999</c:v>
                </c:pt>
                <c:pt idx="1">
                  <c:v>64.630262709230124</c:v>
                </c:pt>
                <c:pt idx="2">
                  <c:v>74.77064724339489</c:v>
                </c:pt>
                <c:pt idx="3">
                  <c:v>80.120788776757891</c:v>
                </c:pt>
                <c:pt idx="4">
                  <c:v>85.07001531149678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BD59-40AD-A2B9-4D2CF0B400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8523456"/>
        <c:axId val="418525024"/>
      </c:scatterChart>
      <c:valAx>
        <c:axId val="418523456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ction</a:t>
                </a:r>
                <a:r>
                  <a:rPr lang="en-US" sz="9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ime (min)</a:t>
                </a:r>
                <a:endParaRPr lang="en-US" sz="9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8406860323848047"/>
              <c:y val="0.9041931770229465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8525024"/>
        <c:crosses val="autoZero"/>
        <c:crossBetween val="midCat"/>
        <c:majorUnit val="5"/>
      </c:valAx>
      <c:valAx>
        <c:axId val="418525024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b="0" i="0" u="none" strike="noStrike" baseline="0" dirty="0">
                    <a:effectLst/>
                  </a:rPr>
                  <a:t>Reducing power  </a:t>
                </a:r>
                <a:endParaRPr lang="en-US" sz="900" b="0" i="0" u="none" strike="noStrike" baseline="0" dirty="0" smtClean="0">
                  <a:effectLst/>
                </a:endParaRPr>
              </a:p>
              <a:p>
                <a:pPr>
                  <a:defRPr sz="9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900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9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ol</a:t>
                </a:r>
                <a:r>
                  <a:rPr lang="en-US" sz="9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E/g placenta protein)</a:t>
                </a:r>
                <a:endParaRPr lang="en-US" sz="9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8523456"/>
        <c:crosses val="autoZero"/>
        <c:crossBetween val="midCat"/>
      </c:valAx>
      <c:spPr>
        <a:noFill/>
        <a:ln w="12700">
          <a:solidFill>
            <a:sysClr val="windowText" lastClr="000000"/>
          </a:solidFill>
        </a:ln>
        <a:effectLst/>
      </c:spPr>
    </c:plotArea>
    <c:legend>
      <c:legendPos val="r"/>
      <c:layout>
        <c:manualLayout>
          <c:xMode val="edge"/>
          <c:yMode val="edge"/>
          <c:x val="0.13758712553752123"/>
          <c:y val="3.5635727244994621E-2"/>
          <c:w val="0.83557959472970766"/>
          <c:h val="9.624614291559692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758241201166879"/>
          <c:y val="4.599812831290466E-2"/>
          <c:w val="0.85009470526155706"/>
          <c:h val="0.7959140507206505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R$140</c:f>
              <c:strCache>
                <c:ptCount val="1"/>
                <c:pt idx="0">
                  <c:v>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68:$O$68</c:f>
                <c:numCache>
                  <c:formatCode>General</c:formatCode>
                  <c:ptCount val="5"/>
                  <c:pt idx="0">
                    <c:v>1.3685710341003562E-2</c:v>
                  </c:pt>
                  <c:pt idx="1">
                    <c:v>0.22972442358112763</c:v>
                  </c:pt>
                  <c:pt idx="2">
                    <c:v>0.75271406875518343</c:v>
                  </c:pt>
                  <c:pt idx="3">
                    <c:v>7.5760182244838187E-2</c:v>
                  </c:pt>
                  <c:pt idx="4">
                    <c:v>0.54742841364013251</c:v>
                  </c:pt>
                </c:numCache>
              </c:numRef>
            </c:plus>
            <c:minus>
              <c:numRef>
                <c:f>Sheet1!$K$68:$O$68</c:f>
                <c:numCache>
                  <c:formatCode>General</c:formatCode>
                  <c:ptCount val="5"/>
                  <c:pt idx="0">
                    <c:v>1.3685710341003562E-2</c:v>
                  </c:pt>
                  <c:pt idx="1">
                    <c:v>0.22972442358112763</c:v>
                  </c:pt>
                  <c:pt idx="2">
                    <c:v>0.75271406875518343</c:v>
                  </c:pt>
                  <c:pt idx="3">
                    <c:v>7.5760182244838187E-2</c:v>
                  </c:pt>
                  <c:pt idx="4">
                    <c:v>0.547428413640132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139:$W$13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140:$W$140</c:f>
              <c:numCache>
                <c:formatCode>General</c:formatCode>
                <c:ptCount val="5"/>
                <c:pt idx="0">
                  <c:v>0.32169117647058798</c:v>
                </c:pt>
                <c:pt idx="1">
                  <c:v>3.088235294117653</c:v>
                </c:pt>
                <c:pt idx="2">
                  <c:v>4.6323529411764763</c:v>
                </c:pt>
                <c:pt idx="3">
                  <c:v>6.6544117647058982</c:v>
                </c:pt>
                <c:pt idx="4">
                  <c:v>7.463235294117659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2F70-4703-90A7-087F22D2FFFE}"/>
            </c:ext>
          </c:extLst>
        </c:ser>
        <c:ser>
          <c:idx val="1"/>
          <c:order val="1"/>
          <c:tx>
            <c:strRef>
              <c:f>Sheet1!$R$141</c:f>
              <c:strCache>
                <c:ptCount val="1"/>
                <c:pt idx="0">
                  <c:v>2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69:$O$69</c:f>
                <c:numCache>
                  <c:formatCode>General</c:formatCode>
                  <c:ptCount val="5"/>
                  <c:pt idx="0">
                    <c:v>0.27371420682006598</c:v>
                  </c:pt>
                  <c:pt idx="1">
                    <c:v>1.8084688664897295</c:v>
                  </c:pt>
                  <c:pt idx="2">
                    <c:v>8.7979566477879689E-2</c:v>
                  </c:pt>
                  <c:pt idx="3">
                    <c:v>0.46922435454868494</c:v>
                  </c:pt>
                  <c:pt idx="4">
                    <c:v>0.70383653182302741</c:v>
                  </c:pt>
                </c:numCache>
              </c:numRef>
            </c:plus>
            <c:minus>
              <c:numRef>
                <c:f>Sheet1!$K$69:$O$69</c:f>
                <c:numCache>
                  <c:formatCode>General</c:formatCode>
                  <c:ptCount val="5"/>
                  <c:pt idx="0">
                    <c:v>0.27371420682006598</c:v>
                  </c:pt>
                  <c:pt idx="1">
                    <c:v>1.8084688664897295</c:v>
                  </c:pt>
                  <c:pt idx="2">
                    <c:v>8.7979566477879689E-2</c:v>
                  </c:pt>
                  <c:pt idx="3">
                    <c:v>0.46922435454868494</c:v>
                  </c:pt>
                  <c:pt idx="4">
                    <c:v>0.703836531823027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139:$W$13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141:$W$141</c:f>
              <c:numCache>
                <c:formatCode>General</c:formatCode>
                <c:ptCount val="5"/>
                <c:pt idx="0">
                  <c:v>0.39705882352939997</c:v>
                </c:pt>
                <c:pt idx="1">
                  <c:v>14.411764705882367</c:v>
                </c:pt>
                <c:pt idx="2">
                  <c:v>14.852941176470598</c:v>
                </c:pt>
                <c:pt idx="3">
                  <c:v>19.117647058823536</c:v>
                </c:pt>
                <c:pt idx="4">
                  <c:v>23.71323529411764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2F70-4703-90A7-087F22D2FFFE}"/>
            </c:ext>
          </c:extLst>
        </c:ser>
        <c:ser>
          <c:idx val="2"/>
          <c:order val="2"/>
          <c:tx>
            <c:strRef>
              <c:f>Sheet1!$R$142</c:f>
              <c:strCache>
                <c:ptCount val="1"/>
                <c:pt idx="0">
                  <c:v>5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70:$O$70</c:f>
                <c:numCache>
                  <c:formatCode>General</c:formatCode>
                  <c:ptCount val="5"/>
                  <c:pt idx="0">
                    <c:v>0.37146928068437807</c:v>
                  </c:pt>
                  <c:pt idx="1">
                    <c:v>0.29326522159292556</c:v>
                  </c:pt>
                  <c:pt idx="2">
                    <c:v>0.37146928068437807</c:v>
                  </c:pt>
                  <c:pt idx="3">
                    <c:v>0.64518348750443433</c:v>
                  </c:pt>
                  <c:pt idx="4">
                    <c:v>0.91889769432449542</c:v>
                  </c:pt>
                </c:numCache>
              </c:numRef>
            </c:plus>
            <c:minus>
              <c:numRef>
                <c:f>Sheet1!$K$70:$O$70</c:f>
                <c:numCache>
                  <c:formatCode>General</c:formatCode>
                  <c:ptCount val="5"/>
                  <c:pt idx="0">
                    <c:v>0.37146928068437807</c:v>
                  </c:pt>
                  <c:pt idx="1">
                    <c:v>0.29326522159292556</c:v>
                  </c:pt>
                  <c:pt idx="2">
                    <c:v>0.37146928068437807</c:v>
                  </c:pt>
                  <c:pt idx="3">
                    <c:v>0.64518348750443433</c:v>
                  </c:pt>
                  <c:pt idx="4">
                    <c:v>0.9188976943244954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139:$W$13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142:$W$142</c:f>
              <c:numCache>
                <c:formatCode>General</c:formatCode>
                <c:ptCount val="5"/>
                <c:pt idx="0">
                  <c:v>0.49264705882352999</c:v>
                </c:pt>
                <c:pt idx="1">
                  <c:v>14.264705882352953</c:v>
                </c:pt>
                <c:pt idx="2">
                  <c:v>21.617647058823536</c:v>
                </c:pt>
                <c:pt idx="3">
                  <c:v>23.786764705882348</c:v>
                </c:pt>
                <c:pt idx="4">
                  <c:v>30.25735294117648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2F70-4703-90A7-087F22D2FFFE}"/>
            </c:ext>
          </c:extLst>
        </c:ser>
        <c:ser>
          <c:idx val="3"/>
          <c:order val="3"/>
          <c:tx>
            <c:strRef>
              <c:f>Sheet1!$R$143</c:f>
              <c:strCache>
                <c:ptCount val="1"/>
                <c:pt idx="0">
                  <c:v>7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161:$O$161</c:f>
                <c:numCache>
                  <c:formatCode>General</c:formatCode>
                  <c:ptCount val="5"/>
                  <c:pt idx="0">
                    <c:v>0.88388347648318943</c:v>
                  </c:pt>
                  <c:pt idx="1">
                    <c:v>0.25996572837740561</c:v>
                  </c:pt>
                  <c:pt idx="2">
                    <c:v>0.41594516540386761</c:v>
                  </c:pt>
                  <c:pt idx="3">
                    <c:v>5.1993145675474341E-2</c:v>
                  </c:pt>
                  <c:pt idx="4">
                    <c:v>0.10398629135095371</c:v>
                  </c:pt>
                </c:numCache>
              </c:numRef>
            </c:plus>
            <c:minus>
              <c:numRef>
                <c:f>Sheet1!$K$161:$O$161</c:f>
                <c:numCache>
                  <c:formatCode>General</c:formatCode>
                  <c:ptCount val="5"/>
                  <c:pt idx="0">
                    <c:v>0.88388347648318943</c:v>
                  </c:pt>
                  <c:pt idx="1">
                    <c:v>0.25996572837740561</c:v>
                  </c:pt>
                  <c:pt idx="2">
                    <c:v>0.41594516540386761</c:v>
                  </c:pt>
                  <c:pt idx="3">
                    <c:v>5.1993145675474341E-2</c:v>
                  </c:pt>
                  <c:pt idx="4">
                    <c:v>0.103986291350953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139:$W$13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143:$W$143</c:f>
              <c:numCache>
                <c:formatCode>General</c:formatCode>
                <c:ptCount val="5"/>
                <c:pt idx="0">
                  <c:v>0.48897058823528999</c:v>
                </c:pt>
                <c:pt idx="1">
                  <c:v>15.919117647058844</c:v>
                </c:pt>
                <c:pt idx="2">
                  <c:v>23.676470588235297</c:v>
                </c:pt>
                <c:pt idx="3">
                  <c:v>30.698529411764714</c:v>
                </c:pt>
                <c:pt idx="4">
                  <c:v>33.45588235294118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2F70-4703-90A7-087F22D2FFFE}"/>
            </c:ext>
          </c:extLst>
        </c:ser>
        <c:ser>
          <c:idx val="4"/>
          <c:order val="4"/>
          <c:tx>
            <c:strRef>
              <c:f>Sheet1!$R$144</c:f>
              <c:strCache>
                <c:ptCount val="1"/>
                <c:pt idx="0">
                  <c:v>1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78:$DA$78</c:f>
                <c:numCache>
                  <c:formatCode>General</c:formatCode>
                  <c:ptCount val="5"/>
                  <c:pt idx="0">
                    <c:v>2.4941780673549072</c:v>
                  </c:pt>
                  <c:pt idx="1">
                    <c:v>0.93866916513357024</c:v>
                  </c:pt>
                  <c:pt idx="2">
                    <c:v>1.6091471402289861</c:v>
                  </c:pt>
                  <c:pt idx="3">
                    <c:v>0.34864854704958254</c:v>
                  </c:pt>
                  <c:pt idx="4">
                    <c:v>1.1264029981602763</c:v>
                  </c:pt>
                </c:numCache>
              </c:numRef>
            </c:plus>
            <c:minus>
              <c:numRef>
                <c:f>DPPH!$CW$78:$DA$78</c:f>
                <c:numCache>
                  <c:formatCode>General</c:formatCode>
                  <c:ptCount val="5"/>
                  <c:pt idx="0">
                    <c:v>2.4941780673549072</c:v>
                  </c:pt>
                  <c:pt idx="1">
                    <c:v>0.93866916513357024</c:v>
                  </c:pt>
                  <c:pt idx="2">
                    <c:v>1.6091471402289861</c:v>
                  </c:pt>
                  <c:pt idx="3">
                    <c:v>0.34864854704958254</c:v>
                  </c:pt>
                  <c:pt idx="4">
                    <c:v>1.12640299816027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S$139:$W$13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S$144:$W$144</c:f>
              <c:numCache>
                <c:formatCode>General</c:formatCode>
                <c:ptCount val="5"/>
                <c:pt idx="0">
                  <c:v>0.74632352941177005</c:v>
                </c:pt>
                <c:pt idx="1">
                  <c:v>19.779411764705884</c:v>
                </c:pt>
                <c:pt idx="2">
                  <c:v>26.948529411764703</c:v>
                </c:pt>
                <c:pt idx="3">
                  <c:v>34.52205882352942</c:v>
                </c:pt>
                <c:pt idx="4">
                  <c:v>36.727941176470594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2F70-4703-90A7-087F22D2FF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8524240"/>
        <c:axId val="418524632"/>
      </c:scatterChart>
      <c:valAx>
        <c:axId val="418524240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ction</a:t>
                </a:r>
                <a:r>
                  <a:rPr lang="en-US" sz="9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ime (min)</a:t>
                </a:r>
                <a:endParaRPr lang="en-US" sz="9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3689350145724615"/>
              <c:y val="0.9041930446158569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8524632"/>
        <c:crosses val="autoZero"/>
        <c:crossBetween val="midCat"/>
        <c:majorUnit val="5"/>
      </c:valAx>
      <c:valAx>
        <c:axId val="418524632"/>
        <c:scaling>
          <c:orientation val="minMax"/>
          <c:max val="5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b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al chelating activity </a:t>
                </a:r>
                <a:r>
                  <a:rPr lang="en-US" sz="900" b="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)</a:t>
                </a:r>
                <a:endParaRPr lang="en-US" sz="900" b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8524240"/>
        <c:crosses val="autoZero"/>
        <c:crossBetween val="midCat"/>
      </c:valAx>
      <c:spPr>
        <a:noFill/>
        <a:ln w="12700">
          <a:solidFill>
            <a:sysClr val="windowText" lastClr="000000"/>
          </a:solidFill>
        </a:ln>
        <a:effectLst/>
      </c:spPr>
    </c:plotArea>
    <c:legend>
      <c:legendPos val="r"/>
      <c:layout>
        <c:manualLayout>
          <c:xMode val="edge"/>
          <c:yMode val="edge"/>
          <c:x val="0.10492451998334786"/>
          <c:y val="5.3060020879185432E-2"/>
          <c:w val="0.85409117419719671"/>
          <c:h val="9.569250051595389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838029794886751"/>
          <c:y val="2.6500731512700437E-2"/>
          <c:w val="0.84208456984609603"/>
          <c:h val="0.8140643014343141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AB$140</c:f>
              <c:strCache>
                <c:ptCount val="1"/>
                <c:pt idx="0">
                  <c:v>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144:$O$144</c:f>
                <c:numCache>
                  <c:formatCode>General</c:formatCode>
                  <c:ptCount val="5"/>
                  <c:pt idx="0">
                    <c:v>0.51993145675481223</c:v>
                  </c:pt>
                  <c:pt idx="1">
                    <c:v>0.51993145675481267</c:v>
                  </c:pt>
                  <c:pt idx="2">
                    <c:v>0.72790403945674542</c:v>
                  </c:pt>
                  <c:pt idx="3">
                    <c:v>0.41594516540385001</c:v>
                  </c:pt>
                  <c:pt idx="4">
                    <c:v>1.7157738072908895</c:v>
                  </c:pt>
                </c:numCache>
              </c:numRef>
            </c:plus>
            <c:minus>
              <c:numRef>
                <c:f>Sheet1!$K$144:$O$144</c:f>
                <c:numCache>
                  <c:formatCode>General</c:formatCode>
                  <c:ptCount val="5"/>
                  <c:pt idx="0">
                    <c:v>0.51993145675481223</c:v>
                  </c:pt>
                  <c:pt idx="1">
                    <c:v>0.51993145675481267</c:v>
                  </c:pt>
                  <c:pt idx="2">
                    <c:v>0.72790403945674542</c:v>
                  </c:pt>
                  <c:pt idx="3">
                    <c:v>0.41594516540385001</c:v>
                  </c:pt>
                  <c:pt idx="4">
                    <c:v>1.71577380729088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C$139:$AG$13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140:$AG$140</c:f>
              <c:numCache>
                <c:formatCode>General</c:formatCode>
                <c:ptCount val="5"/>
                <c:pt idx="0">
                  <c:v>0.4117647058824</c:v>
                </c:pt>
                <c:pt idx="1">
                  <c:v>3.6029411764705976</c:v>
                </c:pt>
                <c:pt idx="2">
                  <c:v>5.6250000000000204</c:v>
                </c:pt>
                <c:pt idx="3">
                  <c:v>6.7647058823529393</c:v>
                </c:pt>
                <c:pt idx="4">
                  <c:v>7.816176470588249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4D3A-4707-A893-BB5B4452CA91}"/>
            </c:ext>
          </c:extLst>
        </c:ser>
        <c:ser>
          <c:idx val="1"/>
          <c:order val="1"/>
          <c:tx>
            <c:strRef>
              <c:f>Sheet1!$AB$141</c:f>
              <c:strCache>
                <c:ptCount val="1"/>
                <c:pt idx="0">
                  <c:v>2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61:$DA$61</c:f>
                <c:numCache>
                  <c:formatCode>General</c:formatCode>
                  <c:ptCount val="5"/>
                  <c:pt idx="0">
                    <c:v>5.3638238007648949E-2</c:v>
                  </c:pt>
                  <c:pt idx="1">
                    <c:v>0.26819119003817438</c:v>
                  </c:pt>
                  <c:pt idx="2">
                    <c:v>5.3638238007618806E-2</c:v>
                  </c:pt>
                  <c:pt idx="3">
                    <c:v>0.34864854704962267</c:v>
                  </c:pt>
                  <c:pt idx="4">
                    <c:v>0.50956326107248917</c:v>
                  </c:pt>
                </c:numCache>
              </c:numRef>
            </c:plus>
            <c:minus>
              <c:numRef>
                <c:f>DPPH!$CW$61:$DA$61</c:f>
                <c:numCache>
                  <c:formatCode>General</c:formatCode>
                  <c:ptCount val="5"/>
                  <c:pt idx="0">
                    <c:v>5.3638238007648949E-2</c:v>
                  </c:pt>
                  <c:pt idx="1">
                    <c:v>0.26819119003817438</c:v>
                  </c:pt>
                  <c:pt idx="2">
                    <c:v>5.3638238007618806E-2</c:v>
                  </c:pt>
                  <c:pt idx="3">
                    <c:v>0.34864854704962267</c:v>
                  </c:pt>
                  <c:pt idx="4">
                    <c:v>0.509563261072489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C$139:$AG$13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141:$AG$141</c:f>
              <c:numCache>
                <c:formatCode>General</c:formatCode>
                <c:ptCount val="5"/>
                <c:pt idx="0">
                  <c:v>0.622058823529413</c:v>
                </c:pt>
                <c:pt idx="1">
                  <c:v>4.1544117647058894</c:v>
                </c:pt>
                <c:pt idx="2">
                  <c:v>7.3602941176470651</c:v>
                </c:pt>
                <c:pt idx="3">
                  <c:v>7.5323529411764696</c:v>
                </c:pt>
                <c:pt idx="4">
                  <c:v>10.6985294117646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4D3A-4707-A893-BB5B4452CA91}"/>
            </c:ext>
          </c:extLst>
        </c:ser>
        <c:ser>
          <c:idx val="2"/>
          <c:order val="2"/>
          <c:tx>
            <c:strRef>
              <c:f>Sheet1!$AB$142</c:f>
              <c:strCache>
                <c:ptCount val="1"/>
                <c:pt idx="0">
                  <c:v>5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146:$O$146</c:f>
                <c:numCache>
                  <c:formatCode>General</c:formatCode>
                  <c:ptCount val="5"/>
                  <c:pt idx="0">
                    <c:v>0.5719246024302862</c:v>
                  </c:pt>
                  <c:pt idx="1">
                    <c:v>0.346620971169875</c:v>
                  </c:pt>
                  <c:pt idx="2">
                    <c:v>0.24263467981891251</c:v>
                  </c:pt>
                  <c:pt idx="3">
                    <c:v>0.3119588740528787</c:v>
                  </c:pt>
                  <c:pt idx="4">
                    <c:v>0.27729677693589999</c:v>
                  </c:pt>
                </c:numCache>
              </c:numRef>
            </c:plus>
            <c:minus>
              <c:numRef>
                <c:f>Sheet1!$K$146:$O$146</c:f>
                <c:numCache>
                  <c:formatCode>General</c:formatCode>
                  <c:ptCount val="5"/>
                  <c:pt idx="0">
                    <c:v>0.5719246024302862</c:v>
                  </c:pt>
                  <c:pt idx="1">
                    <c:v>0.346620971169875</c:v>
                  </c:pt>
                  <c:pt idx="2">
                    <c:v>0.24263467981891251</c:v>
                  </c:pt>
                  <c:pt idx="3">
                    <c:v>0.3119588740528787</c:v>
                  </c:pt>
                  <c:pt idx="4">
                    <c:v>0.2772967769358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C$139:$AG$13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142:$AG$142</c:f>
              <c:numCache>
                <c:formatCode>General</c:formatCode>
                <c:ptCount val="5"/>
                <c:pt idx="0">
                  <c:v>0.54117647058823604</c:v>
                </c:pt>
                <c:pt idx="1">
                  <c:v>4.5588235294117707</c:v>
                </c:pt>
                <c:pt idx="2">
                  <c:v>6.6176470588235343</c:v>
                </c:pt>
                <c:pt idx="3">
                  <c:v>10.735294117647065</c:v>
                </c:pt>
                <c:pt idx="4">
                  <c:v>15.784313725490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4D3A-4707-A893-BB5B4452CA91}"/>
            </c:ext>
          </c:extLst>
        </c:ser>
        <c:ser>
          <c:idx val="3"/>
          <c:order val="3"/>
          <c:tx>
            <c:strRef>
              <c:f>Sheet1!$AB$143</c:f>
              <c:strCache>
                <c:ptCount val="1"/>
                <c:pt idx="0">
                  <c:v>7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rgbClr val="000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58:$O$58</c:f>
                <c:numCache>
                  <c:formatCode>General</c:formatCode>
                  <c:ptCount val="5"/>
                  <c:pt idx="0">
                    <c:v>0.18573464034216644</c:v>
                  </c:pt>
                  <c:pt idx="1">
                    <c:v>0.4398978323893934</c:v>
                  </c:pt>
                  <c:pt idx="2">
                    <c:v>0.33236725113865434</c:v>
                  </c:pt>
                  <c:pt idx="3">
                    <c:v>8.7979566477874666E-2</c:v>
                  </c:pt>
                  <c:pt idx="4">
                    <c:v>0.49855087670796649</c:v>
                  </c:pt>
                </c:numCache>
              </c:numRef>
            </c:plus>
            <c:minus>
              <c:numRef>
                <c:f>Sheet1!$K$58:$O$58</c:f>
                <c:numCache>
                  <c:formatCode>General</c:formatCode>
                  <c:ptCount val="5"/>
                  <c:pt idx="0">
                    <c:v>0.18573464034216644</c:v>
                  </c:pt>
                  <c:pt idx="1">
                    <c:v>0.4398978323893934</c:v>
                  </c:pt>
                  <c:pt idx="2">
                    <c:v>0.33236725113865434</c:v>
                  </c:pt>
                  <c:pt idx="3">
                    <c:v>8.7979566477874666E-2</c:v>
                  </c:pt>
                  <c:pt idx="4">
                    <c:v>0.498550876707966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C$139:$AG$13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143:$AG$143</c:f>
              <c:numCache>
                <c:formatCode>General</c:formatCode>
                <c:ptCount val="5"/>
                <c:pt idx="0">
                  <c:v>0.72500000000000098</c:v>
                </c:pt>
                <c:pt idx="1">
                  <c:v>7.7843137254902004</c:v>
                </c:pt>
                <c:pt idx="2">
                  <c:v>14.338235294117601</c:v>
                </c:pt>
                <c:pt idx="3">
                  <c:v>21.985294117647065</c:v>
                </c:pt>
                <c:pt idx="4">
                  <c:v>25.49019607843138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4D3A-4707-A893-BB5B4452CA91}"/>
            </c:ext>
          </c:extLst>
        </c:ser>
        <c:ser>
          <c:idx val="4"/>
          <c:order val="4"/>
          <c:tx>
            <c:strRef>
              <c:f>Sheet1!$AB$144</c:f>
              <c:strCache>
                <c:ptCount val="1"/>
                <c:pt idx="0">
                  <c:v>1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AC$139:$AG$13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144:$AG$144</c:f>
              <c:numCache>
                <c:formatCode>General</c:formatCode>
                <c:ptCount val="5"/>
                <c:pt idx="0">
                  <c:v>0.70220588235294101</c:v>
                </c:pt>
                <c:pt idx="1">
                  <c:v>21.519607843137255</c:v>
                </c:pt>
                <c:pt idx="2">
                  <c:v>25.588235294117656</c:v>
                </c:pt>
                <c:pt idx="3">
                  <c:v>28.088235294117641</c:v>
                </c:pt>
                <c:pt idx="4">
                  <c:v>29.41176470588235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5-4D3A-4707-A893-BB5B4452CA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8527376"/>
        <c:axId val="406487184"/>
      </c:scatterChart>
      <c:valAx>
        <c:axId val="418527376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ction</a:t>
                </a:r>
                <a:r>
                  <a:rPr lang="en-US" sz="9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ime (min)</a:t>
                </a:r>
                <a:endParaRPr lang="en-US" sz="9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3689365218236609"/>
              <c:y val="0.9041930326830265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06487184"/>
        <c:crosses val="autoZero"/>
        <c:crossBetween val="midCat"/>
        <c:majorUnit val="5"/>
      </c:valAx>
      <c:valAx>
        <c:axId val="406487184"/>
        <c:scaling>
          <c:orientation val="minMax"/>
          <c:max val="5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al chelating</a:t>
                </a:r>
                <a:r>
                  <a:rPr lang="en-US" sz="9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activity (%)</a:t>
                </a:r>
                <a:endParaRPr lang="en-US" sz="9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8527376"/>
        <c:crosses val="autoZero"/>
        <c:crossBetween val="midCat"/>
      </c:valAx>
      <c:spPr>
        <a:noFill/>
        <a:ln w="12700">
          <a:solidFill>
            <a:sysClr val="windowText" lastClr="000000"/>
          </a:solidFill>
        </a:ln>
        <a:effectLst/>
      </c:spPr>
    </c:plotArea>
    <c:legend>
      <c:legendPos val="r"/>
      <c:layout>
        <c:manualLayout>
          <c:xMode val="edge"/>
          <c:yMode val="edge"/>
          <c:x val="0.11778275979391463"/>
          <c:y val="2.8234967797749515E-2"/>
          <c:w val="0.84443259696704565"/>
          <c:h val="0.1164617206422238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476507011473321"/>
          <c:y val="4.8658107137641501E-2"/>
          <c:w val="0.84618289262604918"/>
          <c:h val="0.8140643014343141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A$141</c:f>
              <c:strCache>
                <c:ptCount val="1"/>
                <c:pt idx="0">
                  <c:v>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triang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47:$O$47</c:f>
                <c:numCache>
                  <c:formatCode>General</c:formatCode>
                  <c:ptCount val="5"/>
                  <c:pt idx="0">
                    <c:v>0.18084688664897172</c:v>
                  </c:pt>
                  <c:pt idx="1">
                    <c:v>9.7755073864310635E-2</c:v>
                  </c:pt>
                  <c:pt idx="2">
                    <c:v>0.105086704404131</c:v>
                  </c:pt>
                  <c:pt idx="3">
                    <c:v>6.1096921165196182E-2</c:v>
                  </c:pt>
                  <c:pt idx="4">
                    <c:v>0.16862750241593147</c:v>
                  </c:pt>
                </c:numCache>
              </c:numRef>
            </c:plus>
            <c:minus>
              <c:numRef>
                <c:f>Sheet1!$K$47:$O$47</c:f>
                <c:numCache>
                  <c:formatCode>General</c:formatCode>
                  <c:ptCount val="5"/>
                  <c:pt idx="0">
                    <c:v>0.18084688664897172</c:v>
                  </c:pt>
                  <c:pt idx="1">
                    <c:v>9.7755073864310635E-2</c:v>
                  </c:pt>
                  <c:pt idx="2">
                    <c:v>0.105086704404131</c:v>
                  </c:pt>
                  <c:pt idx="3">
                    <c:v>6.1096921165196182E-2</c:v>
                  </c:pt>
                  <c:pt idx="4">
                    <c:v>0.168627502415931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140:$F$140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141:$F$141</c:f>
              <c:numCache>
                <c:formatCode>General</c:formatCode>
                <c:ptCount val="5"/>
                <c:pt idx="0">
                  <c:v>0.52139705882353105</c:v>
                </c:pt>
                <c:pt idx="1">
                  <c:v>3.95588235294119</c:v>
                </c:pt>
                <c:pt idx="2">
                  <c:v>4.3750000000000071</c:v>
                </c:pt>
                <c:pt idx="3">
                  <c:v>4.8750000000000098</c:v>
                </c:pt>
                <c:pt idx="4">
                  <c:v>4.963235294117651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6350-4194-8C7B-7DB690A5DFBC}"/>
            </c:ext>
          </c:extLst>
        </c:ser>
        <c:ser>
          <c:idx val="1"/>
          <c:order val="1"/>
          <c:tx>
            <c:strRef>
              <c:f>Sheet1!$A$142</c:f>
              <c:strCache>
                <c:ptCount val="1"/>
                <c:pt idx="0">
                  <c:v>2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B$140:$F$140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142:$F$142</c:f>
              <c:numCache>
                <c:formatCode>General</c:formatCode>
                <c:ptCount val="5"/>
                <c:pt idx="0">
                  <c:v>0.71323529411764697</c:v>
                </c:pt>
                <c:pt idx="1">
                  <c:v>8.6666666666666998</c:v>
                </c:pt>
                <c:pt idx="2">
                  <c:v>10.955882352941181</c:v>
                </c:pt>
                <c:pt idx="3">
                  <c:v>13.210784313725494</c:v>
                </c:pt>
                <c:pt idx="4">
                  <c:v>15.14705882352941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6350-4194-8C7B-7DB690A5DFBC}"/>
            </c:ext>
          </c:extLst>
        </c:ser>
        <c:ser>
          <c:idx val="2"/>
          <c:order val="2"/>
          <c:tx>
            <c:strRef>
              <c:f>Sheet1!$A$143</c:f>
              <c:strCache>
                <c:ptCount val="1"/>
                <c:pt idx="0">
                  <c:v>5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49:$O$49</c:f>
                <c:numCache>
                  <c:formatCode>General</c:formatCode>
                  <c:ptCount val="5"/>
                  <c:pt idx="0">
                    <c:v>1.2219384233038985E-2</c:v>
                  </c:pt>
                  <c:pt idx="1">
                    <c:v>0.21261728565487381</c:v>
                  </c:pt>
                  <c:pt idx="2">
                    <c:v>9.775507386430686E-2</c:v>
                  </c:pt>
                  <c:pt idx="3">
                    <c:v>6.1096921165194926E-2</c:v>
                  </c:pt>
                  <c:pt idx="4">
                    <c:v>0.54009678310031206</c:v>
                  </c:pt>
                </c:numCache>
              </c:numRef>
            </c:plus>
            <c:minus>
              <c:numRef>
                <c:f>Sheet1!$K$49:$O$49</c:f>
                <c:numCache>
                  <c:formatCode>General</c:formatCode>
                  <c:ptCount val="5"/>
                  <c:pt idx="0">
                    <c:v>1.2219384233038985E-2</c:v>
                  </c:pt>
                  <c:pt idx="1">
                    <c:v>0.21261728565487381</c:v>
                  </c:pt>
                  <c:pt idx="2">
                    <c:v>9.775507386430686E-2</c:v>
                  </c:pt>
                  <c:pt idx="3">
                    <c:v>6.1096921165194926E-2</c:v>
                  </c:pt>
                  <c:pt idx="4">
                    <c:v>0.540096783100312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140:$F$140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143:$F$143</c:f>
              <c:numCache>
                <c:formatCode>General</c:formatCode>
                <c:ptCount val="5"/>
                <c:pt idx="0">
                  <c:v>0.69852941176470995</c:v>
                </c:pt>
                <c:pt idx="1">
                  <c:v>16.875000000000014</c:v>
                </c:pt>
                <c:pt idx="2">
                  <c:v>19.400735294117659</c:v>
                </c:pt>
                <c:pt idx="3">
                  <c:v>20.257352941176471</c:v>
                </c:pt>
                <c:pt idx="4">
                  <c:v>24.77941176470589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6350-4194-8C7B-7DB690A5DFBC}"/>
            </c:ext>
          </c:extLst>
        </c:ser>
        <c:ser>
          <c:idx val="3"/>
          <c:order val="3"/>
          <c:tx>
            <c:strRef>
              <c:f>Sheet1!$A$144</c:f>
              <c:strCache>
                <c:ptCount val="1"/>
                <c:pt idx="0">
                  <c:v>7.5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50:$O$50</c:f>
                <c:numCache>
                  <c:formatCode>General</c:formatCode>
                  <c:ptCount val="5"/>
                  <c:pt idx="0">
                    <c:v>3.1770399005905878E-2</c:v>
                  </c:pt>
                  <c:pt idx="1">
                    <c:v>0.10264282755753049</c:v>
                  </c:pt>
                  <c:pt idx="2">
                    <c:v>0.26882645312685516</c:v>
                  </c:pt>
                  <c:pt idx="3">
                    <c:v>8.0647935938054291E-2</c:v>
                  </c:pt>
                  <c:pt idx="4">
                    <c:v>0.13685710341003313</c:v>
                  </c:pt>
                </c:numCache>
              </c:numRef>
            </c:plus>
            <c:minus>
              <c:numRef>
                <c:f>Sheet1!$K$50:$O$50</c:f>
                <c:numCache>
                  <c:formatCode>General</c:formatCode>
                  <c:ptCount val="5"/>
                  <c:pt idx="0">
                    <c:v>3.1770399005905878E-2</c:v>
                  </c:pt>
                  <c:pt idx="1">
                    <c:v>0.10264282755753049</c:v>
                  </c:pt>
                  <c:pt idx="2">
                    <c:v>0.26882645312685516</c:v>
                  </c:pt>
                  <c:pt idx="3">
                    <c:v>8.0647935938054291E-2</c:v>
                  </c:pt>
                  <c:pt idx="4">
                    <c:v>0.136857103410033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140:$F$140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144:$F$144</c:f>
              <c:numCache>
                <c:formatCode>General</c:formatCode>
                <c:ptCount val="5"/>
                <c:pt idx="0">
                  <c:v>0.97058823529409999</c:v>
                </c:pt>
                <c:pt idx="1">
                  <c:v>19.352941176470594</c:v>
                </c:pt>
                <c:pt idx="2">
                  <c:v>21.360294117647058</c:v>
                </c:pt>
                <c:pt idx="3">
                  <c:v>24.15441176470588</c:v>
                </c:pt>
                <c:pt idx="4">
                  <c:v>25.91911764705883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6350-4194-8C7B-7DB690A5DFBC}"/>
            </c:ext>
          </c:extLst>
        </c:ser>
        <c:ser>
          <c:idx val="4"/>
          <c:order val="4"/>
          <c:tx>
            <c:strRef>
              <c:f>Sheet1!$A$145</c:f>
              <c:strCache>
                <c:ptCount val="1"/>
                <c:pt idx="0">
                  <c:v>10%</c:v>
                </c:pt>
              </c:strCache>
            </c:strRef>
          </c:tx>
          <c:spPr>
            <a:ln w="12700" cap="rnd">
              <a:solidFill>
                <a:sysClr val="windowText" lastClr="000000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B$140:$F$140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145:$F$145</c:f>
              <c:numCache>
                <c:formatCode>General</c:formatCode>
                <c:ptCount val="5"/>
                <c:pt idx="0">
                  <c:v>0.91544117647058998</c:v>
                </c:pt>
                <c:pt idx="1">
                  <c:v>20.69852941176471</c:v>
                </c:pt>
                <c:pt idx="2">
                  <c:v>21.691176470588232</c:v>
                </c:pt>
                <c:pt idx="3">
                  <c:v>24.227941176470591</c:v>
                </c:pt>
                <c:pt idx="4">
                  <c:v>28.05147058823529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6-6350-4194-8C7B-7DB690A5DF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9985752"/>
        <c:axId val="419990064"/>
      </c:scatterChart>
      <c:valAx>
        <c:axId val="419985752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ction</a:t>
                </a:r>
                <a:r>
                  <a:rPr lang="en-US" sz="9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ime (min)</a:t>
                </a:r>
                <a:endParaRPr lang="en-US" sz="9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3689346604620327"/>
              <c:y val="0.9222977516210043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9990064"/>
        <c:crosses val="autoZero"/>
        <c:crossBetween val="midCat"/>
        <c:majorUnit val="5"/>
      </c:valAx>
      <c:valAx>
        <c:axId val="419990064"/>
        <c:scaling>
          <c:orientation val="minMax"/>
          <c:max val="5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al chelating activity (%)</a:t>
                </a:r>
                <a:endParaRPr lang="en-US" sz="9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9985752"/>
        <c:crosses val="autoZero"/>
        <c:crossBetween val="midCat"/>
      </c:valAx>
      <c:spPr>
        <a:noFill/>
        <a:ln w="12700">
          <a:solidFill>
            <a:sysClr val="windowText" lastClr="000000"/>
          </a:solidFill>
        </a:ln>
        <a:effectLst/>
      </c:spPr>
    </c:plotArea>
    <c:legend>
      <c:legendPos val="r"/>
      <c:layout>
        <c:manualLayout>
          <c:xMode val="edge"/>
          <c:yMode val="edge"/>
          <c:x val="0.10642779093061373"/>
          <c:y val="5.785021627163657E-2"/>
          <c:w val="0.85278102377361964"/>
          <c:h val="7.864186379510575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56398841534922"/>
          <c:y val="2.8326176428484819E-2"/>
          <c:w val="0.8071519791916002"/>
          <c:h val="0.8140643014343141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AB$50</c:f>
              <c:strCache>
                <c:ptCount val="1"/>
                <c:pt idx="0">
                  <c:v>0%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54:$O$54</c:f>
                <c:numCache>
                  <c:formatCode>General</c:formatCode>
                  <c:ptCount val="5"/>
                  <c:pt idx="0">
                    <c:v>5.376529062536952E-2</c:v>
                  </c:pt>
                  <c:pt idx="1">
                    <c:v>0.21017340880826577</c:v>
                  </c:pt>
                  <c:pt idx="2">
                    <c:v>1.4409097887599192</c:v>
                  </c:pt>
                  <c:pt idx="3">
                    <c:v>0.50343863040119263</c:v>
                  </c:pt>
                  <c:pt idx="4">
                    <c:v>0.28348971420649716</c:v>
                  </c:pt>
                </c:numCache>
              </c:numRef>
            </c:plus>
            <c:minus>
              <c:numRef>
                <c:f>Sheet1!$K$54:$O$54</c:f>
                <c:numCache>
                  <c:formatCode>General</c:formatCode>
                  <c:ptCount val="5"/>
                  <c:pt idx="0">
                    <c:v>5.376529062536952E-2</c:v>
                  </c:pt>
                  <c:pt idx="1">
                    <c:v>0.21017340880826577</c:v>
                  </c:pt>
                  <c:pt idx="2">
                    <c:v>1.4409097887599192</c:v>
                  </c:pt>
                  <c:pt idx="3">
                    <c:v>0.50343863040119263</c:v>
                  </c:pt>
                  <c:pt idx="4">
                    <c:v>0.283489714206497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C$49:$AG$4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50:$AG$50</c:f>
              <c:numCache>
                <c:formatCode>General</c:formatCode>
                <c:ptCount val="5"/>
                <c:pt idx="0">
                  <c:v>0</c:v>
                </c:pt>
                <c:pt idx="1">
                  <c:v>14.401834476436465</c:v>
                </c:pt>
                <c:pt idx="2">
                  <c:v>13.642169677319419</c:v>
                </c:pt>
                <c:pt idx="3">
                  <c:v>13.669127754813108</c:v>
                </c:pt>
                <c:pt idx="4">
                  <c:v>14.84076727665423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AC58-42A8-830A-2F47B8BA020C}"/>
            </c:ext>
          </c:extLst>
        </c:ser>
        <c:ser>
          <c:idx val="1"/>
          <c:order val="1"/>
          <c:tx>
            <c:strRef>
              <c:f>Sheet1!$AB$51</c:f>
              <c:strCache>
                <c:ptCount val="1"/>
                <c:pt idx="0">
                  <c:v>2.50%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61:$DA$61</c:f>
                <c:numCache>
                  <c:formatCode>General</c:formatCode>
                  <c:ptCount val="5"/>
                  <c:pt idx="0">
                    <c:v>5.3638238007648949E-2</c:v>
                  </c:pt>
                  <c:pt idx="1">
                    <c:v>0.26819119003817438</c:v>
                  </c:pt>
                  <c:pt idx="2">
                    <c:v>5.3638238007618806E-2</c:v>
                  </c:pt>
                  <c:pt idx="3">
                    <c:v>0.34864854704962267</c:v>
                  </c:pt>
                  <c:pt idx="4">
                    <c:v>0.50956326107248917</c:v>
                  </c:pt>
                </c:numCache>
              </c:numRef>
            </c:plus>
            <c:minus>
              <c:numRef>
                <c:f>DPPH!$CW$61:$DA$61</c:f>
                <c:numCache>
                  <c:formatCode>General</c:formatCode>
                  <c:ptCount val="5"/>
                  <c:pt idx="0">
                    <c:v>5.3638238007648949E-2</c:v>
                  </c:pt>
                  <c:pt idx="1">
                    <c:v>0.26819119003817438</c:v>
                  </c:pt>
                  <c:pt idx="2">
                    <c:v>5.3638238007618806E-2</c:v>
                  </c:pt>
                  <c:pt idx="3">
                    <c:v>0.34864854704962267</c:v>
                  </c:pt>
                  <c:pt idx="4">
                    <c:v>0.509563261072489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C$49:$AG$4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51:$AG$51</c:f>
              <c:numCache>
                <c:formatCode>General</c:formatCode>
                <c:ptCount val="5"/>
                <c:pt idx="0">
                  <c:v>2.7272346466317998</c:v>
                </c:pt>
                <c:pt idx="1">
                  <c:v>49.851706380638241</c:v>
                </c:pt>
                <c:pt idx="2">
                  <c:v>52.146599131383098</c:v>
                </c:pt>
                <c:pt idx="3">
                  <c:v>55.982940928561995</c:v>
                </c:pt>
                <c:pt idx="4">
                  <c:v>62.14182478673567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AC58-42A8-830A-2F47B8BA020C}"/>
            </c:ext>
          </c:extLst>
        </c:ser>
        <c:ser>
          <c:idx val="2"/>
          <c:order val="2"/>
          <c:tx>
            <c:strRef>
              <c:f>Sheet1!$AB$52</c:f>
              <c:strCache>
                <c:ptCount val="1"/>
                <c:pt idx="0">
                  <c:v>5%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PPH!$CW$62:$DA$62</c:f>
                <c:numCache>
                  <c:formatCode>General</c:formatCode>
                  <c:ptCount val="5"/>
                  <c:pt idx="0">
                    <c:v>0.40228678505725157</c:v>
                  </c:pt>
                  <c:pt idx="1">
                    <c:v>1.9041574492709701</c:v>
                  </c:pt>
                  <c:pt idx="2">
                    <c:v>8.0457357011468403E-2</c:v>
                  </c:pt>
                  <c:pt idx="3">
                    <c:v>0.56320149908015815</c:v>
                  </c:pt>
                  <c:pt idx="4">
                    <c:v>0.59002061808396766</c:v>
                  </c:pt>
                </c:numCache>
              </c:numRef>
            </c:plus>
            <c:minus>
              <c:numRef>
                <c:f>DPPH!$CW$62:$DA$62</c:f>
                <c:numCache>
                  <c:formatCode>General</c:formatCode>
                  <c:ptCount val="5"/>
                  <c:pt idx="0">
                    <c:v>0.40228678505725157</c:v>
                  </c:pt>
                  <c:pt idx="1">
                    <c:v>1.9041574492709701</c:v>
                  </c:pt>
                  <c:pt idx="2">
                    <c:v>8.0457357011468403E-2</c:v>
                  </c:pt>
                  <c:pt idx="3">
                    <c:v>0.56320149908015815</c:v>
                  </c:pt>
                  <c:pt idx="4">
                    <c:v>0.590020618083967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C$49:$AG$4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52:$AG$52</c:f>
              <c:numCache>
                <c:formatCode>General</c:formatCode>
                <c:ptCount val="5"/>
                <c:pt idx="0">
                  <c:v>4.4577535474583998</c:v>
                </c:pt>
                <c:pt idx="1">
                  <c:v>57.752496784558033</c:v>
                </c:pt>
                <c:pt idx="2">
                  <c:v>62.611863060984625</c:v>
                </c:pt>
                <c:pt idx="3">
                  <c:v>63.572676592169991</c:v>
                </c:pt>
                <c:pt idx="4">
                  <c:v>70.39514389634219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AC58-42A8-830A-2F47B8BA020C}"/>
            </c:ext>
          </c:extLst>
        </c:ser>
        <c:ser>
          <c:idx val="3"/>
          <c:order val="3"/>
          <c:tx>
            <c:strRef>
              <c:f>Sheet1!$AB$53</c:f>
              <c:strCache>
                <c:ptCount val="1"/>
                <c:pt idx="0">
                  <c:v>7.50%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58:$O$58</c:f>
                <c:numCache>
                  <c:formatCode>General</c:formatCode>
                  <c:ptCount val="5"/>
                  <c:pt idx="0">
                    <c:v>0.18573464034216644</c:v>
                  </c:pt>
                  <c:pt idx="1">
                    <c:v>0.4398978323893934</c:v>
                  </c:pt>
                  <c:pt idx="2">
                    <c:v>0.33236725113865434</c:v>
                  </c:pt>
                  <c:pt idx="3">
                    <c:v>8.7979566477874666E-2</c:v>
                  </c:pt>
                  <c:pt idx="4">
                    <c:v>0.49855087670796649</c:v>
                  </c:pt>
                </c:numCache>
              </c:numRef>
            </c:plus>
            <c:minus>
              <c:numRef>
                <c:f>Sheet1!$K$58:$O$58</c:f>
                <c:numCache>
                  <c:formatCode>General</c:formatCode>
                  <c:ptCount val="5"/>
                  <c:pt idx="0">
                    <c:v>0.18573464034216644</c:v>
                  </c:pt>
                  <c:pt idx="1">
                    <c:v>0.4398978323893934</c:v>
                  </c:pt>
                  <c:pt idx="2">
                    <c:v>0.33236725113865434</c:v>
                  </c:pt>
                  <c:pt idx="3">
                    <c:v>8.7979566477874666E-2</c:v>
                  </c:pt>
                  <c:pt idx="4">
                    <c:v>0.498550876707966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AC$49:$AG$4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53:$AG$53</c:f>
              <c:numCache>
                <c:formatCode>General</c:formatCode>
                <c:ptCount val="5"/>
                <c:pt idx="0">
                  <c:v>6.4322422201235003</c:v>
                </c:pt>
                <c:pt idx="1">
                  <c:v>68.452779851284049</c:v>
                </c:pt>
                <c:pt idx="2">
                  <c:v>70.963337221978421</c:v>
                </c:pt>
                <c:pt idx="3">
                  <c:v>72.337507941400332</c:v>
                </c:pt>
                <c:pt idx="4">
                  <c:v>78.95951774626048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AC58-42A8-830A-2F47B8BA020C}"/>
            </c:ext>
          </c:extLst>
        </c:ser>
        <c:ser>
          <c:idx val="4"/>
          <c:order val="4"/>
          <c:tx>
            <c:strRef>
              <c:f>Sheet1!$AB$54</c:f>
              <c:strCache>
                <c:ptCount val="1"/>
                <c:pt idx="0">
                  <c:v>10%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1!$AC$49:$AG$49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AC$54:$AG$54</c:f>
              <c:numCache>
                <c:formatCode>General</c:formatCode>
                <c:ptCount val="5"/>
                <c:pt idx="0">
                  <c:v>12.005716218401099</c:v>
                </c:pt>
                <c:pt idx="1">
                  <c:v>66.033465204414469</c:v>
                </c:pt>
                <c:pt idx="2">
                  <c:v>75.565564913080593</c:v>
                </c:pt>
                <c:pt idx="3">
                  <c:v>75.116263621519096</c:v>
                </c:pt>
                <c:pt idx="4">
                  <c:v>82.775122560751925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9986144"/>
        <c:axId val="419984968"/>
      </c:scatterChart>
      <c:valAx>
        <c:axId val="419986144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8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ction</a:t>
                </a:r>
                <a:r>
                  <a:rPr lang="en-US" sz="8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ime (min)</a:t>
                </a:r>
                <a:endParaRPr lang="en-US" sz="80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3689350145724615"/>
              <c:y val="0.9041930446158569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9984968"/>
        <c:crosses val="autoZero"/>
        <c:crossBetween val="midCat"/>
        <c:majorUnit val="5"/>
      </c:valAx>
      <c:valAx>
        <c:axId val="419984968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b="0" i="0" u="none" strike="noStrike" baseline="0" dirty="0">
                    <a:solidFill>
                      <a:schemeClr val="tx1"/>
                    </a:solidFill>
                    <a:effectLst/>
                  </a:rPr>
                  <a:t>Reducing power  </a:t>
                </a:r>
                <a:endParaRPr lang="en-US" sz="900" b="0" i="0" u="none" strike="noStrike" baseline="0" dirty="0" smtClean="0">
                  <a:solidFill>
                    <a:schemeClr val="tx1"/>
                  </a:solidFill>
                  <a:effectLst/>
                </a:endParaRPr>
              </a:p>
              <a:p>
                <a:pPr>
                  <a:defRPr sz="9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900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9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ol</a:t>
                </a:r>
                <a:r>
                  <a:rPr lang="en-US" sz="9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E/g placenta protein)</a:t>
                </a:r>
                <a:endParaRPr lang="en-US" sz="9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1015326916688568E-2"/>
              <c:y val="7.34819113263858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9986144"/>
        <c:crosses val="autoZero"/>
        <c:crossBetween val="midCat"/>
      </c:valAx>
      <c:spPr>
        <a:noFill/>
        <a:ln w="12700"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1357670152995529"/>
          <c:y val="3.1660684336011963E-2"/>
          <c:w val="0.82662445826713593"/>
          <c:h val="9.032103202934585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243752220068706"/>
          <c:y val="2.8326207349552879E-2"/>
          <c:w val="0.81803691095170328"/>
          <c:h val="0.84279107793311858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A$51</c:f>
              <c:strCache>
                <c:ptCount val="1"/>
                <c:pt idx="0">
                  <c:v>0%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47:$O$47</c:f>
                <c:numCache>
                  <c:formatCode>General</c:formatCode>
                  <c:ptCount val="5"/>
                  <c:pt idx="0">
                    <c:v>0.18084688664897172</c:v>
                  </c:pt>
                  <c:pt idx="1">
                    <c:v>9.7755073864310635E-2</c:v>
                  </c:pt>
                  <c:pt idx="2">
                    <c:v>0.105086704404131</c:v>
                  </c:pt>
                  <c:pt idx="3">
                    <c:v>6.1096921165196182E-2</c:v>
                  </c:pt>
                  <c:pt idx="4">
                    <c:v>0.16862750241593147</c:v>
                  </c:pt>
                </c:numCache>
              </c:numRef>
            </c:plus>
            <c:minus>
              <c:numRef>
                <c:f>Sheet1!$K$47:$O$47</c:f>
                <c:numCache>
                  <c:formatCode>General</c:formatCode>
                  <c:ptCount val="5"/>
                  <c:pt idx="0">
                    <c:v>0.18084688664897172</c:v>
                  </c:pt>
                  <c:pt idx="1">
                    <c:v>9.7755073864310635E-2</c:v>
                  </c:pt>
                  <c:pt idx="2">
                    <c:v>0.105086704404131</c:v>
                  </c:pt>
                  <c:pt idx="3">
                    <c:v>6.1096921165196182E-2</c:v>
                  </c:pt>
                  <c:pt idx="4">
                    <c:v>0.168627502415931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50:$F$50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51:$F$51</c:f>
              <c:numCache>
                <c:formatCode>General</c:formatCode>
                <c:ptCount val="5"/>
                <c:pt idx="0">
                  <c:v>0.15420918928970001</c:v>
                </c:pt>
                <c:pt idx="1">
                  <c:v>3.3512105248205</c:v>
                </c:pt>
                <c:pt idx="2">
                  <c:v>9.0004099010245007</c:v>
                </c:pt>
                <c:pt idx="3">
                  <c:v>10.193955072774022</c:v>
                </c:pt>
                <c:pt idx="4">
                  <c:v>15.174287081544106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5932-45D9-9AB0-4A8A86AC2E9D}"/>
            </c:ext>
          </c:extLst>
        </c:ser>
        <c:ser>
          <c:idx val="1"/>
          <c:order val="1"/>
          <c:tx>
            <c:strRef>
              <c:f>Sheet1!$A$52</c:f>
              <c:strCache>
                <c:ptCount val="1"/>
                <c:pt idx="0">
                  <c:v>2.50%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B$50:$F$50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52:$F$52</c:f>
              <c:numCache>
                <c:formatCode>General</c:formatCode>
                <c:ptCount val="5"/>
                <c:pt idx="0">
                  <c:v>0.57758925249189996</c:v>
                </c:pt>
                <c:pt idx="1">
                  <c:v>7.7871469001633002</c:v>
                </c:pt>
                <c:pt idx="2">
                  <c:v>14.638581695451556</c:v>
                </c:pt>
                <c:pt idx="3">
                  <c:v>16.074617746557717</c:v>
                </c:pt>
                <c:pt idx="4">
                  <c:v>16.425418370353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5932-45D9-9AB0-4A8A86AC2E9D}"/>
            </c:ext>
          </c:extLst>
        </c:ser>
        <c:ser>
          <c:idx val="2"/>
          <c:order val="2"/>
          <c:tx>
            <c:strRef>
              <c:f>Sheet1!$A$53</c:f>
              <c:strCache>
                <c:ptCount val="1"/>
                <c:pt idx="0">
                  <c:v>5%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49:$O$49</c:f>
                <c:numCache>
                  <c:formatCode>General</c:formatCode>
                  <c:ptCount val="5"/>
                  <c:pt idx="0">
                    <c:v>1.2219384233038985E-2</c:v>
                  </c:pt>
                  <c:pt idx="1">
                    <c:v>0.21261728565487381</c:v>
                  </c:pt>
                  <c:pt idx="2">
                    <c:v>9.775507386430686E-2</c:v>
                  </c:pt>
                  <c:pt idx="3">
                    <c:v>6.1096921165194926E-2</c:v>
                  </c:pt>
                  <c:pt idx="4">
                    <c:v>0.54009678310031206</c:v>
                  </c:pt>
                </c:numCache>
              </c:numRef>
            </c:plus>
            <c:minus>
              <c:numRef>
                <c:f>Sheet1!$K$49:$O$49</c:f>
                <c:numCache>
                  <c:formatCode>General</c:formatCode>
                  <c:ptCount val="5"/>
                  <c:pt idx="0">
                    <c:v>1.2219384233038985E-2</c:v>
                  </c:pt>
                  <c:pt idx="1">
                    <c:v>0.21261728565487381</c:v>
                  </c:pt>
                  <c:pt idx="2">
                    <c:v>9.775507386430686E-2</c:v>
                  </c:pt>
                  <c:pt idx="3">
                    <c:v>6.1096921165194926E-2</c:v>
                  </c:pt>
                  <c:pt idx="4">
                    <c:v>0.540096783100312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50:$F$50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53:$F$53</c:f>
              <c:numCache>
                <c:formatCode>General</c:formatCode>
                <c:ptCount val="5"/>
                <c:pt idx="0">
                  <c:v>0.57758925249189996</c:v>
                </c:pt>
                <c:pt idx="1">
                  <c:v>17.296371643226852</c:v>
                </c:pt>
                <c:pt idx="2">
                  <c:v>18.922496702301331</c:v>
                </c:pt>
                <c:pt idx="3">
                  <c:v>19.181810901252099</c:v>
                </c:pt>
                <c:pt idx="4">
                  <c:v>19.01754120628549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5932-45D9-9AB0-4A8A86AC2E9D}"/>
            </c:ext>
          </c:extLst>
        </c:ser>
        <c:ser>
          <c:idx val="3"/>
          <c:order val="3"/>
          <c:tx>
            <c:strRef>
              <c:f>Sheet1!$A$54</c:f>
              <c:strCache>
                <c:ptCount val="1"/>
                <c:pt idx="0">
                  <c:v>7.50%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tar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50:$O$50</c:f>
                <c:numCache>
                  <c:formatCode>General</c:formatCode>
                  <c:ptCount val="5"/>
                  <c:pt idx="0">
                    <c:v>3.1770399005905878E-2</c:v>
                  </c:pt>
                  <c:pt idx="1">
                    <c:v>0.10264282755753049</c:v>
                  </c:pt>
                  <c:pt idx="2">
                    <c:v>0.26882645312685516</c:v>
                  </c:pt>
                  <c:pt idx="3">
                    <c:v>8.0647935938054291E-2</c:v>
                  </c:pt>
                  <c:pt idx="4">
                    <c:v>0.13685710341003313</c:v>
                  </c:pt>
                </c:numCache>
              </c:numRef>
            </c:plus>
            <c:minus>
              <c:numRef>
                <c:f>Sheet1!$K$50:$O$50</c:f>
                <c:numCache>
                  <c:formatCode>General</c:formatCode>
                  <c:ptCount val="5"/>
                  <c:pt idx="0">
                    <c:v>3.1770399005905878E-2</c:v>
                  </c:pt>
                  <c:pt idx="1">
                    <c:v>0.10264282755753049</c:v>
                  </c:pt>
                  <c:pt idx="2">
                    <c:v>0.26882645312685516</c:v>
                  </c:pt>
                  <c:pt idx="3">
                    <c:v>8.0647935938054291E-2</c:v>
                  </c:pt>
                  <c:pt idx="4">
                    <c:v>0.136857103410033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50:$F$50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54:$F$54</c:f>
              <c:numCache>
                <c:formatCode>General</c:formatCode>
                <c:ptCount val="5"/>
                <c:pt idx="0">
                  <c:v>0.57758925249189996</c:v>
                </c:pt>
                <c:pt idx="1">
                  <c:v>19.363667161197601</c:v>
                </c:pt>
                <c:pt idx="2">
                  <c:v>23.215052118604206</c:v>
                </c:pt>
                <c:pt idx="3">
                  <c:v>24.488648471991979</c:v>
                </c:pt>
                <c:pt idx="4">
                  <c:v>25.7381015167927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5932-45D9-9AB0-4A8A86AC2E9D}"/>
            </c:ext>
          </c:extLst>
        </c:ser>
        <c:ser>
          <c:idx val="4"/>
          <c:order val="4"/>
          <c:tx>
            <c:strRef>
              <c:f>Sheet1!$A$55</c:f>
              <c:strCache>
                <c:ptCount val="1"/>
                <c:pt idx="0">
                  <c:v>10%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6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51:$O$51</c:f>
                <c:numCache>
                  <c:formatCode>General</c:formatCode>
                  <c:ptCount val="5"/>
                  <c:pt idx="0">
                    <c:v>9.7755073864271673E-3</c:v>
                  </c:pt>
                  <c:pt idx="1">
                    <c:v>7.8204059091450007E-2</c:v>
                  </c:pt>
                  <c:pt idx="2">
                    <c:v>0.12219384233038734</c:v>
                  </c:pt>
                  <c:pt idx="3">
                    <c:v>0.11486221179056444</c:v>
                  </c:pt>
                  <c:pt idx="4">
                    <c:v>0.19062239403540013</c:v>
                  </c:pt>
                </c:numCache>
              </c:numRef>
            </c:plus>
            <c:minus>
              <c:numRef>
                <c:f>Sheet1!$K$51:$O$51</c:f>
                <c:numCache>
                  <c:formatCode>General</c:formatCode>
                  <c:ptCount val="5"/>
                  <c:pt idx="0">
                    <c:v>9.7755073864271673E-3</c:v>
                  </c:pt>
                  <c:pt idx="1">
                    <c:v>7.8204059091450007E-2</c:v>
                  </c:pt>
                  <c:pt idx="2">
                    <c:v>0.12219384233038734</c:v>
                  </c:pt>
                  <c:pt idx="3">
                    <c:v>0.11486221179056444</c:v>
                  </c:pt>
                  <c:pt idx="4">
                    <c:v>0.190622394035400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1!$B$50:$F$50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</c:numCache>
            </c:numRef>
          </c:xVal>
          <c:yVal>
            <c:numRef>
              <c:f>Sheet1!$B$55:$F$55</c:f>
              <c:numCache>
                <c:formatCode>General</c:formatCode>
                <c:ptCount val="5"/>
                <c:pt idx="0">
                  <c:v>0.57758925249189996</c:v>
                </c:pt>
                <c:pt idx="1">
                  <c:v>21.243820258193399</c:v>
                </c:pt>
                <c:pt idx="2">
                  <c:v>25.575611981192665</c:v>
                </c:pt>
                <c:pt idx="3">
                  <c:v>25.518585278802171</c:v>
                </c:pt>
                <c:pt idx="4">
                  <c:v>26.25993240987863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5932-45D9-9AB0-4A8A86AC2E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9989672"/>
        <c:axId val="419983792"/>
      </c:scatterChart>
      <c:valAx>
        <c:axId val="419989672"/>
        <c:scaling>
          <c:orientation val="minMax"/>
          <c:max val="2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action</a:t>
                </a:r>
                <a:r>
                  <a:rPr lang="en-US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ime (min)</a:t>
                </a:r>
                <a:endParaRPr lang="en-US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3309835796142182"/>
              <c:y val="0.918473726387407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9983792"/>
        <c:crosses val="autoZero"/>
        <c:crossBetween val="midCat"/>
        <c:majorUnit val="5"/>
      </c:valAx>
      <c:valAx>
        <c:axId val="419983792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ducing power  </a:t>
                </a:r>
                <a:endParaRPr lang="en-US" sz="900" baseline="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defRPr sz="9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900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</a:t>
                </a:r>
                <a:r>
                  <a:rPr lang="en-US" sz="900" baseline="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ol</a:t>
                </a:r>
                <a:r>
                  <a:rPr lang="en-US" sz="9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TE/g placenta protein)</a:t>
                </a:r>
                <a:endParaRPr lang="en-US" sz="9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9989672"/>
        <c:crosses val="autoZero"/>
        <c:crossBetween val="midCat"/>
      </c:valAx>
      <c:spPr>
        <a:noFill/>
        <a:ln w="12700"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11554913965725261"/>
          <c:y val="3.7845494749851508E-2"/>
          <c:w val="0.85240830432887582"/>
          <c:h val="5.591000754912939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th-T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8A00E7-4D81-4B24-84C3-DCED635936A3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th-T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931CA3-B140-4DE2-AD28-FE7296121422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8795052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15384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19978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09884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055732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481731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02754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947171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20632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48166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211300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10521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3E26D-3564-4493-97E8-C33A46FC47F0}" type="datetimeFigureOut">
              <a:rPr lang="th-TH" smtClean="0"/>
              <a:t>29/05/64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C7F709-3B63-4E55-AC54-36456AA4C92A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06193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733403AF-6242-4225-8622-4F609A7AB7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52962218"/>
              </p:ext>
            </p:extLst>
          </p:nvPr>
        </p:nvGraphicFramePr>
        <p:xfrm>
          <a:off x="70635" y="596570"/>
          <a:ext cx="3439864" cy="26158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59403A91-7128-4699-A539-A850C8F0912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6826955"/>
              </p:ext>
            </p:extLst>
          </p:nvPr>
        </p:nvGraphicFramePr>
        <p:xfrm>
          <a:off x="3468832" y="560596"/>
          <a:ext cx="3254835" cy="26552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3DF389F9-87FA-4528-8391-B2AF5535168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2913952"/>
              </p:ext>
            </p:extLst>
          </p:nvPr>
        </p:nvGraphicFramePr>
        <p:xfrm>
          <a:off x="3410331" y="3174718"/>
          <a:ext cx="3291840" cy="25682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lc="http://schemas.openxmlformats.org/drawingml/2006/lockedCanvas" xmlns:a16="http://schemas.microsoft.com/office/drawing/2014/main" xmlns:xdr="http://schemas.openxmlformats.org/drawingml/2006/spreadsheetDrawing" xmlns="" id="{B6936D12-92A2-43A7-9335-1AD15A186E1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2049734"/>
              </p:ext>
            </p:extLst>
          </p:nvPr>
        </p:nvGraphicFramePr>
        <p:xfrm>
          <a:off x="3427452" y="5699901"/>
          <a:ext cx="3294600" cy="26568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xdr="http://schemas.openxmlformats.org/drawingml/2006/spreadsheetDrawing" xmlns="" xmlns:a16="http://schemas.microsoft.com/office/drawing/2014/main" xmlns:lc="http://schemas.openxmlformats.org/drawingml/2006/lockedCanvas" id="{F49AD38D-EF8A-4CA7-B5FF-9CE96B85025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3878065"/>
              </p:ext>
            </p:extLst>
          </p:nvPr>
        </p:nvGraphicFramePr>
        <p:xfrm>
          <a:off x="0" y="3182638"/>
          <a:ext cx="3458817" cy="25656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3261586" y="596570"/>
            <a:ext cx="453225" cy="31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228132" y="3228451"/>
            <a:ext cx="453225" cy="31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475560" y="596570"/>
            <a:ext cx="453225" cy="31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475559" y="3174718"/>
            <a:ext cx="453225" cy="31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535192" y="5771979"/>
            <a:ext cx="3935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0" name="Chart 19">
            <a:extLst>
              <a:ext uri="{FF2B5EF4-FFF2-40B4-BE49-F238E27FC236}">
                <a16:creationId xmlns:xdr="http://schemas.openxmlformats.org/drawingml/2006/spreadsheetDrawing" xmlns:a16="http://schemas.microsoft.com/office/drawing/2014/main" xmlns="" xmlns:lc="http://schemas.openxmlformats.org/drawingml/2006/lockedCanvas" id="{B028E300-735B-4517-A7A8-A7EBBD4704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7432863"/>
              </p:ext>
            </p:extLst>
          </p:nvPr>
        </p:nvGraphicFramePr>
        <p:xfrm>
          <a:off x="69850" y="5771979"/>
          <a:ext cx="3355752" cy="2578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3205830" y="5755939"/>
            <a:ext cx="453225" cy="310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34329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95</TotalTime>
  <Words>85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rdia New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DELL</cp:lastModifiedBy>
  <cp:revision>424</cp:revision>
  <dcterms:created xsi:type="dcterms:W3CDTF">2019-11-18T02:47:29Z</dcterms:created>
  <dcterms:modified xsi:type="dcterms:W3CDTF">2021-05-29T08:37:19Z</dcterms:modified>
</cp:coreProperties>
</file>